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34526-0EE3-4935-B98B-388269DD8A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BF3C0-F0AF-4826-B32E-EB886A652D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F5993-DB1D-4CE4-91E3-52299A94E30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1EC49-D7EF-4190-BC28-D1A40927CE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1D87B6-C8DA-45B4-9589-3E0C149238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EE078-3E01-41D7-9391-7F7C8E8E8C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8B1F8-84D8-4105-81BB-6E353ECCE9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C1021-4165-409D-BF53-C87EF375E0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BB972-A6FC-4055-B2E8-7D044C73CA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743B2-ABBE-408F-B9EE-FB1068421D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01829-B96F-43AF-ABCD-C8FE69F019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073CB-045A-4E71-8E09-6BF19B3B43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FAB320-BAAF-4578-B549-ABCA799F93E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C:\Documents and Settings\Ishiyama H\デスクトップ\PC3.png"/>
          <p:cNvPicPr/>
          <p:nvPr/>
        </p:nvPicPr>
        <p:blipFill>
          <a:blip r:embed="rId1">
            <a:grayscl/>
          </a:blip>
          <a:srcRect l="0" t="22176" r="0" b="0"/>
          <a:stretch/>
        </p:blipFill>
        <p:spPr>
          <a:xfrm>
            <a:off x="609480" y="1066680"/>
            <a:ext cx="5434200" cy="406872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1842840" y="5638680"/>
            <a:ext cx="325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ao et al Supplemental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Chart 5" descr=""/>
          <p:cNvPicPr/>
          <p:nvPr/>
        </p:nvPicPr>
        <p:blipFill>
          <a:blip r:embed="rId1"/>
          <a:stretch/>
        </p:blipFill>
        <p:spPr>
          <a:xfrm>
            <a:off x="450720" y="835200"/>
            <a:ext cx="5559480" cy="4475160"/>
          </a:xfrm>
          <a:prstGeom prst="rect">
            <a:avLst/>
          </a:prstGeom>
          <a:ln w="0">
            <a:noFill/>
          </a:ln>
        </p:spPr>
      </p:pic>
      <p:sp>
        <p:nvSpPr>
          <p:cNvPr id="44" name="TextBox 4"/>
          <p:cNvSpPr/>
          <p:nvPr/>
        </p:nvSpPr>
        <p:spPr>
          <a:xfrm>
            <a:off x="1690560" y="6095880"/>
            <a:ext cx="325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ao et al Supplemental 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"/>
          <p:cNvPicPr/>
          <p:nvPr/>
        </p:nvPicPr>
        <p:blipFill>
          <a:blip r:embed="rId1"/>
          <a:stretch/>
        </p:blipFill>
        <p:spPr>
          <a:xfrm>
            <a:off x="1143000" y="838080"/>
            <a:ext cx="4213080" cy="5373720"/>
          </a:xfrm>
          <a:prstGeom prst="rect">
            <a:avLst/>
          </a:prstGeom>
          <a:ln w="0">
            <a:noFill/>
          </a:ln>
        </p:spPr>
      </p:pic>
      <p:sp>
        <p:nvSpPr>
          <p:cNvPr id="46" name="TextBox 4"/>
          <p:cNvSpPr/>
          <p:nvPr/>
        </p:nvSpPr>
        <p:spPr>
          <a:xfrm>
            <a:off x="1461960" y="7467480"/>
            <a:ext cx="3254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Gao et al Supplemental 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08T19:48:51Z</dcterms:created>
  <dc:creator>testuser</dc:creator>
  <dc:description/>
  <dc:language>en-US</dc:language>
  <cp:lastModifiedBy>testuser</cp:lastModifiedBy>
  <dcterms:modified xsi:type="dcterms:W3CDTF">2011-01-13T22:26:26Z</dcterms:modified>
  <cp:revision>2</cp:revision>
  <dc:subject/>
  <dc:title>Slide 1</dc:title>
</cp:coreProperties>
</file>